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embeddings/oleObject1.bin" ContentType="application/vnd.openxmlformats-officedocument.oleObject"/>
  <Override PartName="/ppt/embeddings/oleObject2.bin" ContentType="application/vnd.openxmlformats-officedocument.oleObject"/>
  <Override PartName="/ppt/embeddings/oleObject3.bin" ContentType="application/vnd.openxmlformats-officedocument.oleObject"/>
  <Override PartName="/ppt/media/image1.png" ContentType="image/png"/>
  <Override PartName="/ppt/media/image2.png" ContentType="image/png"/>
  <Override PartName="/ppt/media/image3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215ECAD-1526-45BB-A8F4-F38387DC2018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E0201FF-019E-4BA4-AC81-E98115D63C6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59DF9FB-5BD5-4338-BCFA-EBB8316A22B9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CAB6478-0695-43D7-8F91-5533AF1E12BD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D68D06F-DD80-4ED6-BEC8-2947E79E1E0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E82EB0B-F076-4D31-BB80-ACEF3B3F23A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AC97675-DE96-4ED1-B8DB-522B2576D1E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A2B8CC2-EA4E-4D30-B284-361285425E0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A90325B-9792-4926-9DFB-E27968F9375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9E9C6DC-042F-4414-A8DC-29FE3791AB2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B28D8F8-1EF4-4127-9E99-0E2561693C1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AC265AF-9BF5-4949-9F2A-05596E07429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A4EFA2E-A423-4A5C-BAF2-B916E380AC9C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1.png"/><Relationship Id="rId3" Type="http://schemas.openxmlformats.org/officeDocument/2006/relationships/oleObject" Target="../embeddings/oleObject2.bin"/><Relationship Id="rId4" Type="http://schemas.openxmlformats.org/officeDocument/2006/relationships/image" Target="../media/image2.png"/><Relationship Id="rId5" Type="http://schemas.openxmlformats.org/officeDocument/2006/relationships/oleObject" Target="../embeddings/oleObject3.bin"/><Relationship Id="rId6" Type="http://schemas.openxmlformats.org/officeDocument/2006/relationships/image" Target="../media/image3.png"/><Relationship Id="rId7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Rectangle 15"/>
          <p:cNvSpPr/>
          <p:nvPr/>
        </p:nvSpPr>
        <p:spPr>
          <a:xfrm>
            <a:off x="876240" y="2560680"/>
            <a:ext cx="7296120" cy="1113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Figure S3: Validation of expression of selected cytokine genes by quantitative RT-PCR.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 Total RNA was isolated from glioblastoma and prostate cancer cells (DU145, n = 1; all other cell lines n = 2) 24 h after photofrin (PC-3) or 5-ALA-based PDT (conditions are summarized in Table S1). Control cells were also incubated with photofrin or 5-ALA, however, were not irradiated. The relative cDNA level of IL6 (A), CXCL8 (B) and CXCL14 (C) were determined by quantitative RT-PCR. The thus determined cDNA levels were correlated with the levels estimated from oligonucleotide microarray experiments shown in Fig. 5. A high degree of agreement between the two different quantitation methods was noted (coefficient of determination R</a:t>
            </a:r>
            <a:r>
              <a:rPr b="0" lang="en-US" sz="1000" spc="-1" strike="noStrike" baseline="30000">
                <a:solidFill>
                  <a:srgbClr val="000000"/>
                </a:solidFill>
                <a:latin typeface="Arial"/>
                <a:ea typeface="ＭＳ Ｐゴシック"/>
              </a:rPr>
              <a:t>2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 = 0.947 ± 0.072). Significance levels (P) were calculated using two-way ANOVA.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2" name="Group 21"/>
          <p:cNvGrpSpPr/>
          <p:nvPr/>
        </p:nvGrpSpPr>
        <p:grpSpPr>
          <a:xfrm>
            <a:off x="8443800" y="5084640"/>
            <a:ext cx="5761080" cy="1143000"/>
            <a:chOff x="8443800" y="5084640"/>
            <a:chExt cx="5761080" cy="1143000"/>
          </a:xfrm>
        </p:grpSpPr>
        <p:sp>
          <p:nvSpPr>
            <p:cNvPr id="43" name="AutoShape 22"/>
            <p:cNvSpPr/>
            <p:nvPr/>
          </p:nvSpPr>
          <p:spPr>
            <a:xfrm>
              <a:off x="8443800" y="5084640"/>
              <a:ext cx="5761080" cy="1143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" name="Text Box 23"/>
            <p:cNvSpPr/>
            <p:nvPr/>
          </p:nvSpPr>
          <p:spPr>
            <a:xfrm>
              <a:off x="8443800" y="5084640"/>
              <a:ext cx="5716080" cy="1066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65880" rIns="65880" tIns="32760" bIns="327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45" name=""/>
          <p:cNvGrpSpPr/>
          <p:nvPr/>
        </p:nvGrpSpPr>
        <p:grpSpPr>
          <a:xfrm>
            <a:off x="755640" y="403200"/>
            <a:ext cx="7362720" cy="2060640"/>
            <a:chOff x="755640" y="403200"/>
            <a:chExt cx="7362720" cy="2060640"/>
          </a:xfrm>
        </p:grpSpPr>
        <p:graphicFrame>
          <p:nvGraphicFramePr>
            <p:cNvPr id="46" name=""/>
            <p:cNvGraphicFramePr/>
            <p:nvPr/>
          </p:nvGraphicFramePr>
          <p:xfrm>
            <a:off x="755640" y="490680"/>
            <a:ext cx="2592360" cy="1957320"/>
          </p:xfrm>
          <a:graphic>
            <a:graphicData uri="http://schemas.openxmlformats.org/presentationml/2006/ole">
              <p:oleObj r:id="rId1" spid="">
                <p:embed/>
                <p:pic>
                  <p:nvPicPr>
                    <p:cNvPr id="47" name="" descr=""/>
                    <p:cNvPicPr/>
                    <p:nvPr/>
                  </p:nvPicPr>
                  <p:blipFill>
                    <a:blip r:embed="rId2"/>
                    <a:stretch/>
                  </p:blipFill>
                  <p:spPr>
                    <a:xfrm>
                      <a:off x="755640" y="490680"/>
                      <a:ext cx="2592360" cy="195732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sp>
          <p:nvSpPr>
            <p:cNvPr id="48" name=""/>
            <p:cNvSpPr/>
            <p:nvPr/>
          </p:nvSpPr>
          <p:spPr>
            <a:xfrm>
              <a:off x="3076560" y="549360"/>
              <a:ext cx="11952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A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"/>
            <p:cNvSpPr/>
            <p:nvPr/>
          </p:nvSpPr>
          <p:spPr>
            <a:xfrm>
              <a:off x="1949760" y="423720"/>
              <a:ext cx="723240" cy="413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100" spc="-1" strike="noStrike">
                  <a:solidFill>
                    <a:srgbClr val="000000"/>
                  </a:solidFill>
                  <a:latin typeface="Arial"/>
                </a:rPr>
                <a:t>IL6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1000" spc="-1" strike="noStrike">
                  <a:solidFill>
                    <a:srgbClr val="000000"/>
                  </a:solidFill>
                  <a:latin typeface="Arial"/>
                </a:rPr>
                <a:t>P = 0.002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aphicFrame>
          <p:nvGraphicFramePr>
            <p:cNvPr id="50" name=""/>
            <p:cNvGraphicFramePr/>
            <p:nvPr/>
          </p:nvGraphicFramePr>
          <p:xfrm>
            <a:off x="3419640" y="542880"/>
            <a:ext cx="2466720" cy="1920960"/>
          </p:xfrm>
          <a:graphic>
            <a:graphicData uri="http://schemas.openxmlformats.org/presentationml/2006/ole">
              <p:oleObj r:id="rId3" spid="">
                <p:embed/>
                <p:pic>
                  <p:nvPicPr>
                    <p:cNvPr id="51" name="" descr=""/>
                    <p:cNvPicPr/>
                    <p:nvPr/>
                  </p:nvPicPr>
                  <p:blipFill>
                    <a:blip r:embed="rId4"/>
                    <a:stretch/>
                  </p:blipFill>
                  <p:spPr>
                    <a:xfrm>
                      <a:off x="3419640" y="542880"/>
                      <a:ext cx="2466720" cy="192096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sp>
          <p:nvSpPr>
            <p:cNvPr id="52" name=""/>
            <p:cNvSpPr/>
            <p:nvPr/>
          </p:nvSpPr>
          <p:spPr>
            <a:xfrm>
              <a:off x="4375440" y="411120"/>
              <a:ext cx="723240" cy="413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100" spc="-1" strike="noStrike">
                  <a:solidFill>
                    <a:srgbClr val="000000"/>
                  </a:solidFill>
                  <a:latin typeface="Arial"/>
                </a:rPr>
                <a:t>CXCL8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P = 0.009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"/>
            <p:cNvSpPr/>
            <p:nvPr/>
          </p:nvSpPr>
          <p:spPr>
            <a:xfrm>
              <a:off x="5486400" y="549360"/>
              <a:ext cx="11952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B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aphicFrame>
          <p:nvGraphicFramePr>
            <p:cNvPr id="54" name=""/>
            <p:cNvGraphicFramePr/>
            <p:nvPr/>
          </p:nvGraphicFramePr>
          <p:xfrm>
            <a:off x="5796000" y="527040"/>
            <a:ext cx="2322360" cy="1920960"/>
          </p:xfrm>
          <a:graphic>
            <a:graphicData uri="http://schemas.openxmlformats.org/presentationml/2006/ole">
              <p:oleObj r:id="rId5" spid="">
                <p:embed/>
                <p:pic>
                  <p:nvPicPr>
                    <p:cNvPr id="55" name="" descr=""/>
                    <p:cNvPicPr/>
                    <p:nvPr/>
                  </p:nvPicPr>
                  <p:blipFill>
                    <a:blip r:embed="rId6"/>
                    <a:stretch/>
                  </p:blipFill>
                  <p:spPr>
                    <a:xfrm>
                      <a:off x="5796000" y="527040"/>
                      <a:ext cx="2322360" cy="192096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sp>
          <p:nvSpPr>
            <p:cNvPr id="56" name=""/>
            <p:cNvSpPr/>
            <p:nvPr/>
          </p:nvSpPr>
          <p:spPr>
            <a:xfrm>
              <a:off x="6753600" y="403200"/>
              <a:ext cx="723240" cy="413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100" spc="-1" strike="noStrike">
                  <a:solidFill>
                    <a:srgbClr val="000000"/>
                  </a:solidFill>
                  <a:latin typeface="Arial"/>
                </a:rPr>
                <a:t>CXCL14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P &lt; 0.00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"/>
            <p:cNvSpPr/>
            <p:nvPr/>
          </p:nvSpPr>
          <p:spPr>
            <a:xfrm>
              <a:off x="7846920" y="549360"/>
              <a:ext cx="12888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C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3-29T17:03:16Z</dcterms:created>
  <dc:creator>Prof. W. Zimmermann</dc:creator>
  <dc:description/>
  <dc:language>en-US</dc:language>
  <cp:lastModifiedBy>Prof. W. Zimmermann</cp:lastModifiedBy>
  <dcterms:modified xsi:type="dcterms:W3CDTF">2011-05-10T08:08:09Z</dcterms:modified>
  <cp:revision>29</cp:revision>
  <dc:subject/>
  <dc:title>Folie 1</dc:title>
</cp:coreProperties>
</file>